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140754491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1"/>
    <p:restoredTop sz="96327"/>
  </p:normalViewPr>
  <p:slideViewPr>
    <p:cSldViewPr snapToGrid="0" snapToObjects="1" showGuides="1">
      <p:cViewPr varScale="1">
        <p:scale>
          <a:sx n="128" d="100"/>
          <a:sy n="128" d="100"/>
        </p:scale>
        <p:origin x="480" y="17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498B368-F1B3-0245-95A4-8A5768AB854F}" type="datetimeFigureOut">
              <a:rPr lang="en-US" smtClean="0"/>
              <a:t>8/13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C654732-3731-D34B-A754-A38BD1D213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3127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6D4B4D-86AA-2D8B-49C9-B9730EB40A9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632E16B-998E-C07C-46DF-A2A359F9AAC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FAAD85-AB7F-2BD5-CC76-8617642D98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04144AE-C7EF-A1B1-3DF8-AC3A3EC46C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1874B88-59EE-7ACE-EE58-CFDE8A40AF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54129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646BCD-3DA5-7EA2-1E41-C25DCA4AA4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20D5E7B-83C0-A78B-1F0E-DDE0115054A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FBF3E42-D991-C08A-8527-15E816CAF3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A2D6FCB-A00A-E1AD-70BB-07A34490D2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95AEB75-EB08-C39D-B1CF-63C8704061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80733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CD7C3C5-71C0-A1B2-9F1F-887D392FD73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78EE4FF-0CB6-7D57-F380-770CED4ED50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BCBFCF-8EBD-F4B4-2D80-0B4ECE8FA2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3494CF6-5D71-408F-63AF-14742B78C0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402F832-B7F9-D4D6-70EB-D52EED4B81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236273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7_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406B85D-899C-944F-A2E0-4894DCE9224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Subtitle 2">
            <a:extLst>
              <a:ext uri="{FF2B5EF4-FFF2-40B4-BE49-F238E27FC236}">
                <a16:creationId xmlns:a16="http://schemas.microsoft.com/office/drawing/2014/main" id="{E28CA5FF-AACC-4AB7-B6E7-D6A63EA944DB}"/>
              </a:ext>
            </a:extLst>
          </p:cNvPr>
          <p:cNvSpPr>
            <a:spLocks noGrp="1"/>
          </p:cNvSpPr>
          <p:nvPr>
            <p:ph type="subTitle" idx="10" hasCustomPrompt="1"/>
          </p:nvPr>
        </p:nvSpPr>
        <p:spPr>
          <a:xfrm>
            <a:off x="614853" y="1161597"/>
            <a:ext cx="10962290" cy="276999"/>
          </a:xfrm>
        </p:spPr>
        <p:txBody>
          <a:bodyPr wrap="square">
            <a:spAutoFit/>
          </a:bodyPr>
          <a:lstStyle>
            <a:lvl1pPr marL="0" indent="0" algn="l">
              <a:buNone/>
              <a:defRPr sz="2000" b="0" i="0" baseline="0">
                <a:solidFill>
                  <a:schemeClr val="accent3"/>
                </a:solidFill>
                <a:latin typeface="+mn-lt"/>
                <a:cs typeface="Gotham Bold" pitchFamily="2" charset="0"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subtitle</a:t>
            </a:r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EDEDEA15-1C46-42C0-9541-5C897D1A89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6" name="Footnotes">
            <a:extLst>
              <a:ext uri="{FF2B5EF4-FFF2-40B4-BE49-F238E27FC236}">
                <a16:creationId xmlns:a16="http://schemas.microsoft.com/office/drawing/2014/main" id="{38ABFE29-F12E-4908-BBBE-F167F72BD474}"/>
              </a:ext>
            </a:extLst>
          </p:cNvPr>
          <p:cNvSpPr>
            <a:spLocks noGrp="1"/>
          </p:cNvSpPr>
          <p:nvPr>
            <p:ph type="body" sz="quarter" idx="11" hasCustomPrompt="1"/>
          </p:nvPr>
        </p:nvSpPr>
        <p:spPr>
          <a:xfrm>
            <a:off x="614854" y="6019800"/>
            <a:ext cx="9139237" cy="352572"/>
          </a:xfrm>
        </p:spPr>
        <p:txBody>
          <a:bodyPr anchor="b">
            <a:noAutofit/>
          </a:bodyPr>
          <a:lstStyle>
            <a:lvl1pPr marL="115888" indent="-115888">
              <a:spcBef>
                <a:spcPts val="300"/>
              </a:spcBef>
              <a:spcAft>
                <a:spcPts val="0"/>
              </a:spcAft>
              <a:buFont typeface="+mj-lt"/>
              <a:buAutoNum type="arabicPeriod"/>
              <a:defRPr sz="800">
                <a:solidFill>
                  <a:schemeClr val="tx2"/>
                </a:solidFill>
                <a:latin typeface="+mn-lt"/>
              </a:defRPr>
            </a:lvl1pPr>
            <a:lvl2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2pPr>
            <a:lvl3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3pPr>
            <a:lvl4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4pPr>
            <a:lvl5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5pPr>
            <a:lvl6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6pPr>
            <a:lvl7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7pPr>
            <a:lvl8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8pPr>
            <a:lvl9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9pPr>
          </a:lstStyle>
          <a:p>
            <a:pPr lvl="0"/>
            <a:r>
              <a:rPr lang="en-US"/>
              <a:t>Click to add a reference</a:t>
            </a:r>
          </a:p>
        </p:txBody>
      </p:sp>
    </p:spTree>
    <p:extLst>
      <p:ext uri="{BB962C8B-B14F-4D97-AF65-F5344CB8AC3E}">
        <p14:creationId xmlns:p14="http://schemas.microsoft.com/office/powerpoint/2010/main" val="934693454"/>
      </p:ext>
    </p:extLst>
  </p:cSld>
  <p:clrMapOvr>
    <a:masterClrMapping/>
  </p:clrMapOvr>
  <p:transition spd="med">
    <p:fade/>
  </p:transition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1E4477-E2C6-333E-7719-D0110A0908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F211F44-6541-C656-9423-672E6D4C77D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B29360A-D345-B9A3-98F9-2562CCC59F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6E9D474-E09B-F229-AB05-E741B9383A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2D80891-93F2-2BDA-12FD-391EF77104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27529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D10A86-25F3-EC62-2093-A0ACF40761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28D1118-8BAB-76B5-FEC7-9E984780E62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16786A5-6961-99B3-B7EB-B08C9FB7AD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DD05593-D3B5-A46B-1E20-3B42FE3BD3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DDAF183-D6B4-F12F-D3B6-BE37280548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2173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D50339-6B24-28B7-6731-6F50E65F6F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DFF5F1F-0CC3-D379-35E9-AD524FCE355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75D30D2-22CF-A94E-163A-05B2B4A6BD8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30F88EA-B300-6990-1E88-45239B2589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BAA1BEC-C618-848F-79D7-BA954C8898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A31C6AC-69F2-5A13-03C3-3AD481CA91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5680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627115-C71D-868B-9F4C-036DB1422F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CB570CC-37EC-5849-B1AE-CF42709C639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723A815-562C-CA29-DF83-E3B05239E1D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3DA066F-F142-A310-FBC5-11C5467C2E3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98045C0-914C-67C6-2AB6-E07E6944A4C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83214B8-9017-1262-AFAC-B7D33BC338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F9F62EE-DAB4-B597-8FFF-B358848CD0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D738EFA-0729-2895-CC19-0D8A1CE2B7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29370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D62CF3-AE73-DB7D-1832-42A1839918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F82E599-7E90-14DC-69BE-FE02C24707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B84F30C-C766-9DF0-2F92-574037DD09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2463212-7AB9-4CCE-05AE-4AC30D8979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58725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50F5844-E514-2665-0563-A742A46D50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1C0F884-2473-FEBA-C949-15C20EB5D1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66191E0-7615-C448-3E88-96FC4E4BF0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06507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EBBDE2-AC71-BB30-926A-AC6C84A77F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A5F1FCB-4A60-EECB-216B-78FED4CE6C3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A9111C4-7F35-030A-B351-BEFC9876DAE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CBAEC91-AA23-18EF-976F-CE19C3A6DA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ABE547F-263A-36B2-F6EC-F1692140AA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533B1D8-A907-D8BE-F3BD-5A81D708A5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60518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2FE9E7-0B82-593B-427F-E268B23E06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7019921-432F-E8A3-FE40-2108DAC74A6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0D1C407-FD24-64F3-FB38-C90E252D594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14FE28B-DC92-0E6F-6691-8FB68A8A86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A0E5EB2-A374-0635-223E-B497A52800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65BC3EB-9B62-4587-EC39-B7B1EB86BD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10090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F579E1B-4AD0-A052-060E-38E99E5F92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FAE9465-F527-A2C4-C944-745A6C335AE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1C55A13-8B0A-9713-675C-36D57B45C1B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D0A70C-5E4E-D09F-3996-A0A001D4F96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DC7EC20-85C0-BCBD-ABF8-AA0F691DADF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88396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graphical user interface&#10;&#10;Description automatically generated">
            <a:extLst>
              <a:ext uri="{FF2B5EF4-FFF2-40B4-BE49-F238E27FC236}">
                <a16:creationId xmlns:a16="http://schemas.microsoft.com/office/drawing/2014/main" id="{999D3066-90A0-1244-A636-C7D2BBE6087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76228" y="311251"/>
            <a:ext cx="6029240" cy="4019493"/>
          </a:xfrm>
          <a:prstGeom prst="rect">
            <a:avLst/>
          </a:prstGeom>
        </p:spPr>
      </p:pic>
      <p:sp>
        <p:nvSpPr>
          <p:cNvPr id="4" name="Title 3">
            <a:extLst>
              <a:ext uri="{FF2B5EF4-FFF2-40B4-BE49-F238E27FC236}">
                <a16:creationId xmlns:a16="http://schemas.microsoft.com/office/drawing/2014/main" id="{FFCC8002-5932-7943-BCBF-D5460FC72D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86531" y="229500"/>
            <a:ext cx="4170506" cy="512256"/>
          </a:xfrm>
        </p:spPr>
        <p:txBody>
          <a:bodyPr>
            <a:noAutofit/>
          </a:bodyPr>
          <a:lstStyle/>
          <a:p>
            <a:r>
              <a:rPr lang="en-US" sz="2800" dirty="0">
                <a:latin typeface="Calibri" panose="020F0502020204030204" pitchFamily="34" charset="0"/>
                <a:cs typeface="Calibri" panose="020F0502020204030204" pitchFamily="34" charset="0"/>
              </a:rPr>
              <a:t>Supplemental Figure 7</a:t>
            </a:r>
          </a:p>
        </p:txBody>
      </p:sp>
      <p:sp>
        <p:nvSpPr>
          <p:cNvPr id="5" name="Content Placeholder 1">
            <a:extLst>
              <a:ext uri="{FF2B5EF4-FFF2-40B4-BE49-F238E27FC236}">
                <a16:creationId xmlns:a16="http://schemas.microsoft.com/office/drawing/2014/main" id="{18F39F3C-F56B-9640-B152-EB6E98BDE8A8}"/>
              </a:ext>
            </a:extLst>
          </p:cNvPr>
          <p:cNvSpPr txBox="1">
            <a:spLocks/>
          </p:cNvSpPr>
          <p:nvPr/>
        </p:nvSpPr>
        <p:spPr>
          <a:xfrm>
            <a:off x="286531" y="982701"/>
            <a:ext cx="4716394" cy="1626684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>
            <a:lvl1pPr marL="0" indent="6350" algn="l" defTabSz="914400" rtl="0" eaLnBrk="1" latinLnBrk="0" hangingPunct="1">
              <a:lnSpc>
                <a:spcPct val="90000"/>
              </a:lnSpc>
              <a:spcBef>
                <a:spcPts val="1000"/>
              </a:spcBef>
              <a:spcAft>
                <a:spcPts val="600"/>
              </a:spcAft>
              <a:buFont typeface="Arial" panose="020B0604020202020204" pitchFamily="34" charset="0"/>
              <a:buChar char="​"/>
              <a:defRPr sz="2000" kern="1200">
                <a:solidFill>
                  <a:schemeClr val="tx1"/>
                </a:solidFill>
                <a:latin typeface="Gotham Bold" pitchFamily="50" charset="0"/>
                <a:ea typeface="+mn-ea"/>
                <a:cs typeface="Gotham Bold" pitchFamily="50" charset="0"/>
              </a:defRPr>
            </a:lvl1pPr>
            <a:lvl2pPr marL="1714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>
                <a:schemeClr val="accent3"/>
              </a:buClr>
              <a:buSzPct val="100000"/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2pPr>
            <a:lvl3pPr marL="4000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Tx/>
              <a:buSzPct val="75000"/>
              <a:buFont typeface="Gotham Book" pitchFamily="50" charset="0"/>
              <a:buChar char="−"/>
              <a:defRPr sz="16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3pPr>
            <a:lvl4pPr marL="6286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Tx/>
              <a:buSzPct val="75000"/>
              <a:buFont typeface="Gotham Book" pitchFamily="50" charset="0"/>
              <a:buChar char="−"/>
              <a:defRPr sz="16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4pPr>
            <a:lvl5pPr marL="8572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Tx/>
              <a:buSzPct val="75000"/>
              <a:buFont typeface="Gotham Book" pitchFamily="50" charset="0"/>
              <a:buChar char="−"/>
              <a:defRPr sz="16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5pPr>
            <a:lvl6pPr marL="8572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Tx/>
              <a:buSzPct val="75000"/>
              <a:buFont typeface="Gotham Book" pitchFamily="50" charset="0"/>
              <a:buChar char="−"/>
              <a:defRPr sz="16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6pPr>
            <a:lvl7pPr marL="8572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Tx/>
              <a:buSzPct val="75000"/>
              <a:buFont typeface="Gotham Book" pitchFamily="50" charset="0"/>
              <a:buChar char="−"/>
              <a:defRPr sz="16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7pPr>
            <a:lvl8pPr marL="8572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Tx/>
              <a:buSzPct val="75000"/>
              <a:buFont typeface="Gotham Book" pitchFamily="50" charset="0"/>
              <a:buChar char="−"/>
              <a:defRPr sz="16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8pPr>
            <a:lvl9pPr marL="8572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Tx/>
              <a:buSzPct val="75000"/>
              <a:buFont typeface="GT Sectra Book" panose="02000503070000020003" pitchFamily="50" charset="0"/>
              <a:buChar char="“"/>
              <a:defRPr sz="16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9pPr>
          </a:lstStyle>
          <a:p>
            <a:pPr indent="0">
              <a:buNone/>
            </a:pPr>
            <a:r>
              <a:rPr lang="en-US" sz="1400" b="1" dirty="0">
                <a:latin typeface="Calibri" panose="020F0502020204030204" pitchFamily="34" charset="0"/>
                <a:cs typeface="Calibri" panose="020F0502020204030204" pitchFamily="34" charset="0"/>
              </a:rPr>
              <a:t>Discriminatory Power Comparison of MSI and TMB. </a:t>
            </a:r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The concordance indexes from univariable Cox PH models containing NGS-based MSI assessment, TMB, or the two in a combined multivariable Cox PH model is shown with (A) TTNT and (B) OS. Error bars indicate standard error. 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8F55CCB-2980-7D4B-8758-89C73B1EB72A}"/>
              </a:ext>
            </a:extLst>
          </p:cNvPr>
          <p:cNvSpPr txBox="1"/>
          <p:nvPr/>
        </p:nvSpPr>
        <p:spPr>
          <a:xfrm>
            <a:off x="5866610" y="457258"/>
            <a:ext cx="4587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Calibri" panose="020F0502020204030204" pitchFamily="34" charset="0"/>
                <a:cs typeface="Calibri" panose="020F0502020204030204" pitchFamily="34" charset="0"/>
              </a:rPr>
              <a:t>(A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8217153-DE30-724C-8437-6B9095C6936A}"/>
              </a:ext>
            </a:extLst>
          </p:cNvPr>
          <p:cNvSpPr txBox="1"/>
          <p:nvPr/>
        </p:nvSpPr>
        <p:spPr>
          <a:xfrm>
            <a:off x="5876228" y="2240053"/>
            <a:ext cx="4491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>
                <a:latin typeface="Calibri" panose="020F0502020204030204" pitchFamily="34" charset="0"/>
                <a:cs typeface="Calibri" panose="020F0502020204030204" pitchFamily="34" charset="0"/>
              </a:rPr>
              <a:t>(B)</a:t>
            </a:r>
          </a:p>
        </p:txBody>
      </p:sp>
    </p:spTree>
    <p:extLst>
      <p:ext uri="{BB962C8B-B14F-4D97-AF65-F5344CB8AC3E}">
        <p14:creationId xmlns:p14="http://schemas.microsoft.com/office/powerpoint/2010/main" val="2473133873"/>
      </p:ext>
    </p:extLst>
  </p:cSld>
  <p:clrMapOvr>
    <a:masterClrMapping/>
  </p:clrMapOvr>
  <p:transition spd="med">
    <p:fade/>
  </p:transition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0</TotalTime>
  <Words>61</Words>
  <Application>Microsoft Macintosh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Supplemental Figure 7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l Tables &amp; Figures</dc:title>
  <dc:creator>Klempner, Samuel J.,MD</dc:creator>
  <cp:lastModifiedBy>Klempner, Samuel J.,MD</cp:lastModifiedBy>
  <cp:revision>10</cp:revision>
  <dcterms:created xsi:type="dcterms:W3CDTF">2022-06-12T16:24:02Z</dcterms:created>
  <dcterms:modified xsi:type="dcterms:W3CDTF">2022-08-13T14:34:36Z</dcterms:modified>
</cp:coreProperties>
</file>